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B0AF0151-9361-4123-8B5E-D38324843CE7}">
          <p14:sldIdLst/>
        </p14:section>
        <p14:section name="无标题节" id="{031C27FF-B83F-4552-8E20-7CF25D858727}">
          <p14:sldIdLst>
            <p14:sldId id="29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engzhishu2009@163.com" initials="f" lastIdx="10" clrIdx="0">
    <p:extLst>
      <p:ext uri="{19B8F6BF-5375-455C-9EA6-DF929625EA0E}">
        <p15:presenceInfo xmlns:p15="http://schemas.microsoft.com/office/powerpoint/2012/main" userId="696e086e05cbe20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284F9E"/>
    <a:srgbClr val="595959"/>
    <a:srgbClr val="6E4D83"/>
    <a:srgbClr val="F2A2D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891" autoAdjust="0"/>
    <p:restoredTop sz="93826" autoAdjust="0"/>
  </p:normalViewPr>
  <p:slideViewPr>
    <p:cSldViewPr snapToGrid="0" showGuides="1">
      <p:cViewPr varScale="1">
        <p:scale>
          <a:sx n="44" d="100"/>
          <a:sy n="44" d="100"/>
        </p:scale>
        <p:origin x="2116" y="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&#23454;&#39564;&#25968;&#25454;\&#23450;&#37327;&#32467;&#26524;\2019\&#31319;&#22411;&#30456;&#20851;&#22522;&#22240;&#23450;&#37327;\20191018-1%20FBK12%20CSLD4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19\&#31319;&#22411;&#30456;&#20851;&#22522;&#22240;&#23450;&#37327;\20191010-2%20APO2%20DST%20SP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19\&#31319;&#22411;&#30456;&#20851;&#22522;&#22240;&#23450;&#37327;\20191010-2%20APO2%20DST%20SP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19\&#31319;&#22411;&#30456;&#20851;&#22522;&#22240;&#23450;&#37327;\20191010-4%20TUT1%20D11%20DTH7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19\&#31319;&#22411;&#30456;&#20851;&#22522;&#22240;&#23450;&#37327;\20191019-1DEP1%20OSCKX2%20TWA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19\&#31319;&#22411;&#30456;&#20851;&#22522;&#22240;&#23450;&#37327;\20191010-1%20PAY1%20TWA1%20FUWA1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19\&#31319;&#22411;&#30456;&#20851;&#22522;&#22240;&#23450;&#37327;\20191010-1%20PAY1%20TWA1%20FUWA1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21&#23567;&#35770;&#25991;&#34917;&#23454;&#39564;\20210531-3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386637643329795"/>
          <c:y val="3.551141305994817E-2"/>
          <c:w val="0.69353556872240529"/>
          <c:h val="0.8446685739876289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60000"/>
                <a:lumOff val="4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C55-46D5-952E-8F8007D87867}"/>
              </c:ext>
            </c:extLst>
          </c:dPt>
          <c:errBars>
            <c:errBarType val="both"/>
            <c:errValType val="cust"/>
            <c:noEndCap val="0"/>
            <c:plus>
              <c:numRef>
                <c:f>Sheet3!$K$19:$K$20</c:f>
                <c:numCache>
                  <c:formatCode>General</c:formatCode>
                  <c:ptCount val="2"/>
                  <c:pt idx="0">
                    <c:v>3.2795974690322652E-2</c:v>
                  </c:pt>
                  <c:pt idx="1">
                    <c:v>3.1971480747395142E-2</c:v>
                  </c:pt>
                </c:numCache>
              </c:numRef>
            </c:plus>
            <c:minus>
              <c:numRef>
                <c:f>Sheet3!$K$19:$K$20</c:f>
                <c:numCache>
                  <c:formatCode>General</c:formatCode>
                  <c:ptCount val="2"/>
                  <c:pt idx="0">
                    <c:v>3.2795974690322652E-2</c:v>
                  </c:pt>
                  <c:pt idx="1">
                    <c:v>3.1971480747395142E-2</c:v>
                  </c:pt>
                </c:numCache>
              </c:numRef>
            </c:minus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</c:errBars>
          <c:cat>
            <c:strRef>
              <c:f>Sheet3!$L$26:$L$27</c:f>
              <c:strCache>
                <c:ptCount val="2"/>
                <c:pt idx="0">
                  <c:v>Nip </c:v>
                </c:pt>
                <c:pt idx="1">
                  <c:v>CSSL-9</c:v>
                </c:pt>
              </c:strCache>
            </c:strRef>
          </c:cat>
          <c:val>
            <c:numRef>
              <c:f>Sheet3!$M$26:$M$27</c:f>
              <c:numCache>
                <c:formatCode>General</c:formatCode>
                <c:ptCount val="2"/>
                <c:pt idx="0">
                  <c:v>1.0357806877201643</c:v>
                </c:pt>
                <c:pt idx="1">
                  <c:v>0.94007517305936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C55-46D5-952E-8F8007D878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658372608"/>
        <c:axId val="1"/>
      </c:barChart>
      <c:catAx>
        <c:axId val="658372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837260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19050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70705447533344"/>
          <c:y val="8.6369770580296892E-2"/>
          <c:w val="0.79129680218544107"/>
          <c:h val="0.82287906319402382"/>
        </c:manualLayout>
      </c:layout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644374560"/>
        <c:axId val="644371280"/>
      </c:barChart>
      <c:catAx>
        <c:axId val="644374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44371280"/>
        <c:crosses val="autoZero"/>
        <c:auto val="1"/>
        <c:lblAlgn val="ctr"/>
        <c:lblOffset val="100"/>
        <c:noMultiLvlLbl val="0"/>
      </c:catAx>
      <c:valAx>
        <c:axId val="6443712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443745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471943518929275"/>
          <c:y val="3.4540298743726133E-2"/>
          <c:w val="0.82528056481070722"/>
          <c:h val="0.848916351210831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712-48C0-81D9-E20514FEDE2B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712-48C0-81D9-E20514FEDE2B}"/>
              </c:ext>
            </c:extLst>
          </c:dPt>
          <c:errBars>
            <c:errBarType val="both"/>
            <c:errValType val="cust"/>
            <c:noEndCap val="0"/>
            <c:plus>
              <c:numRef>
                <c:f>Sheet3!$L$2:$L$3</c:f>
                <c:numCache>
                  <c:formatCode>General</c:formatCode>
                  <c:ptCount val="2"/>
                  <c:pt idx="0">
                    <c:v>0.355858808905267</c:v>
                  </c:pt>
                  <c:pt idx="1">
                    <c:v>0.10581228539990156</c:v>
                  </c:pt>
                </c:numCache>
              </c:numRef>
            </c:plus>
            <c:minus>
              <c:numRef>
                <c:f>Sheet3!$L$2:$L$3</c:f>
                <c:numCache>
                  <c:formatCode>General</c:formatCode>
                  <c:ptCount val="2"/>
                  <c:pt idx="0">
                    <c:v>0.355858808905267</c:v>
                  </c:pt>
                  <c:pt idx="1">
                    <c:v>0.10581228539990156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3!$N$2:$N$3</c:f>
              <c:strCache>
                <c:ptCount val="2"/>
                <c:pt idx="0">
                  <c:v>Nip </c:v>
                </c:pt>
                <c:pt idx="1">
                  <c:v>CSSL-9</c:v>
                </c:pt>
              </c:strCache>
            </c:strRef>
          </c:cat>
          <c:val>
            <c:numRef>
              <c:f>Sheet3!$O$2:$O$3</c:f>
              <c:numCache>
                <c:formatCode>General</c:formatCode>
                <c:ptCount val="2"/>
                <c:pt idx="0">
                  <c:v>1.0503338996802405</c:v>
                </c:pt>
                <c:pt idx="1">
                  <c:v>1.0996050192199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712-48C0-81D9-E20514FEDE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644374560"/>
        <c:axId val="644371280"/>
      </c:barChart>
      <c:catAx>
        <c:axId val="644374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44371280"/>
        <c:crosses val="autoZero"/>
        <c:auto val="1"/>
        <c:lblAlgn val="ctr"/>
        <c:lblOffset val="100"/>
        <c:noMultiLvlLbl val="0"/>
      </c:catAx>
      <c:valAx>
        <c:axId val="6443712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443745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737097827339418"/>
          <c:y val="3.5761596889411336E-2"/>
          <c:w val="0.80044844394450676"/>
          <c:h val="0.8435742381770503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564-4F7D-BC99-C216C7F122C3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564-4F7D-BC99-C216C7F122C3}"/>
              </c:ext>
            </c:extLst>
          </c:dPt>
          <c:errBars>
            <c:errBarType val="both"/>
            <c:errValType val="cust"/>
            <c:noEndCap val="0"/>
            <c:plus>
              <c:numRef>
                <c:f>Sheet3!$K$22:$K$23</c:f>
                <c:numCache>
                  <c:formatCode>General</c:formatCode>
                  <c:ptCount val="2"/>
                  <c:pt idx="0">
                    <c:v>5.3477578724081959E-2</c:v>
                  </c:pt>
                  <c:pt idx="1">
                    <c:v>2.7491860331517463E-2</c:v>
                  </c:pt>
                </c:numCache>
              </c:numRef>
            </c:plus>
            <c:minus>
              <c:numRef>
                <c:f>Sheet3!$K$22:$K$23</c:f>
                <c:numCache>
                  <c:formatCode>General</c:formatCode>
                  <c:ptCount val="2"/>
                  <c:pt idx="0">
                    <c:v>5.3477578724081959E-2</c:v>
                  </c:pt>
                  <c:pt idx="1">
                    <c:v>2.7491860331517463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3!$J$27:$J$28</c:f>
              <c:strCache>
                <c:ptCount val="2"/>
                <c:pt idx="0">
                  <c:v>Nip </c:v>
                </c:pt>
                <c:pt idx="1">
                  <c:v>CSSL-9</c:v>
                </c:pt>
              </c:strCache>
            </c:strRef>
          </c:cat>
          <c:val>
            <c:numRef>
              <c:f>Sheet3!$K$27:$K$28</c:f>
              <c:numCache>
                <c:formatCode>General</c:formatCode>
                <c:ptCount val="2"/>
                <c:pt idx="0">
                  <c:v>0.94106285378002097</c:v>
                </c:pt>
                <c:pt idx="1">
                  <c:v>0.877039522287176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564-4F7D-BC99-C216C7F122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512837672"/>
        <c:axId val="512839312"/>
      </c:barChart>
      <c:catAx>
        <c:axId val="512837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12839312"/>
        <c:crosses val="autoZero"/>
        <c:auto val="1"/>
        <c:lblAlgn val="ctr"/>
        <c:lblOffset val="100"/>
        <c:noMultiLvlLbl val="0"/>
      </c:catAx>
      <c:valAx>
        <c:axId val="512839312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solidFill>
            <a:schemeClr val="bg1"/>
          </a:solidFill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1283767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04980146712431"/>
          <c:y val="2.826962786379756E-2"/>
          <c:w val="0.79690288713910762"/>
          <c:h val="0.876345061191740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60000"/>
                <a:lumOff val="4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4FB-452A-A448-93311E3F7EDE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J$18:$J$19</c:f>
                <c:numCache>
                  <c:formatCode>General</c:formatCode>
                  <c:ptCount val="2"/>
                  <c:pt idx="0">
                    <c:v>0.14888878106550038</c:v>
                  </c:pt>
                  <c:pt idx="1">
                    <c:v>9.3386106644708394E-2</c:v>
                  </c:pt>
                </c:numCache>
              </c:numRef>
            </c:plus>
            <c:minus>
              <c:numRef>
                <c:f>Sheet2!$J$18:$J$19</c:f>
                <c:numCache>
                  <c:formatCode>General</c:formatCode>
                  <c:ptCount val="2"/>
                  <c:pt idx="0">
                    <c:v>0.14888878106550038</c:v>
                  </c:pt>
                  <c:pt idx="1">
                    <c:v>9.3386106644708394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I$10:$I$11</c:f>
              <c:strCache>
                <c:ptCount val="2"/>
                <c:pt idx="0">
                  <c:v>Nip</c:v>
                </c:pt>
                <c:pt idx="1">
                  <c:v>CSSL-9</c:v>
                </c:pt>
              </c:strCache>
            </c:strRef>
          </c:cat>
          <c:val>
            <c:numRef>
              <c:f>Sheet2!$J$10:$J$11</c:f>
              <c:numCache>
                <c:formatCode>General</c:formatCode>
                <c:ptCount val="2"/>
                <c:pt idx="0">
                  <c:v>0.85111121893449937</c:v>
                </c:pt>
                <c:pt idx="1">
                  <c:v>0.673681517712727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4FB-452A-A448-93311E3F7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527942512"/>
        <c:axId val="527942840"/>
      </c:barChart>
      <c:catAx>
        <c:axId val="527942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27942840"/>
        <c:crosses val="autoZero"/>
        <c:auto val="1"/>
        <c:lblAlgn val="ctr"/>
        <c:lblOffset val="100"/>
        <c:noMultiLvlLbl val="0"/>
      </c:catAx>
      <c:valAx>
        <c:axId val="5279428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27942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272680098368792"/>
          <c:y val="2.9180203133466302E-2"/>
          <c:w val="0.88389129483814521"/>
          <c:h val="0.8651009326616017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BFE-44C9-BE15-FA8121EB7874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BFE-44C9-BE15-FA8121EB7874}"/>
              </c:ext>
            </c:extLst>
          </c:dPt>
          <c:errBars>
            <c:errBarType val="both"/>
            <c:errValType val="cust"/>
            <c:noEndCap val="0"/>
            <c:plus>
              <c:numRef>
                <c:f>Sheet3!$J$7:$J$8</c:f>
                <c:numCache>
                  <c:formatCode>General</c:formatCode>
                  <c:ptCount val="2"/>
                  <c:pt idx="0">
                    <c:v>2.0889761468512003E-2</c:v>
                  </c:pt>
                  <c:pt idx="1">
                    <c:v>2.6777874595757572E-2</c:v>
                  </c:pt>
                </c:numCache>
              </c:numRef>
            </c:plus>
            <c:minus>
              <c:numRef>
                <c:f>Sheet3!$J$7:$J$8</c:f>
                <c:numCache>
                  <c:formatCode>General</c:formatCode>
                  <c:ptCount val="2"/>
                  <c:pt idx="0">
                    <c:v>2.0889761468512003E-2</c:v>
                  </c:pt>
                  <c:pt idx="1">
                    <c:v>2.6777874595757572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3!$N$2:$N$3</c:f>
              <c:strCache>
                <c:ptCount val="2"/>
                <c:pt idx="0">
                  <c:v>Nip </c:v>
                </c:pt>
                <c:pt idx="1">
                  <c:v>CSSL-9</c:v>
                </c:pt>
              </c:strCache>
            </c:strRef>
          </c:cat>
          <c:val>
            <c:numRef>
              <c:f>Sheet3!$O$2:$O$3</c:f>
              <c:numCache>
                <c:formatCode>General</c:formatCode>
                <c:ptCount val="2"/>
                <c:pt idx="0">
                  <c:v>0.98191016449365709</c:v>
                </c:pt>
                <c:pt idx="1">
                  <c:v>0.946436464847306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BFE-44C9-BE15-FA8121EB78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657921400"/>
        <c:axId val="657923040"/>
      </c:barChart>
      <c:catAx>
        <c:axId val="657921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7923040"/>
        <c:crosses val="autoZero"/>
        <c:auto val="1"/>
        <c:lblAlgn val="ctr"/>
        <c:lblOffset val="100"/>
        <c:noMultiLvlLbl val="0"/>
      </c:catAx>
      <c:valAx>
        <c:axId val="657923040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5792140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899759405074366E-2"/>
          <c:y val="6.0185185185185182E-2"/>
          <c:w val="0.89655796150481193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C7F-4EB3-AC6B-C9C0F40FC7ED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C7F-4EB3-AC6B-C9C0F40FC7ED}"/>
              </c:ext>
            </c:extLst>
          </c:dPt>
          <c:errBars>
            <c:errBarType val="both"/>
            <c:errValType val="cust"/>
            <c:noEndCap val="0"/>
            <c:plus>
              <c:numRef>
                <c:f>Sheet3!$K$37:$K$38</c:f>
                <c:numCache>
                  <c:formatCode>General</c:formatCode>
                  <c:ptCount val="2"/>
                  <c:pt idx="0">
                    <c:v>5.8803888517886267E-2</c:v>
                  </c:pt>
                  <c:pt idx="1">
                    <c:v>2.4527124971578704E-2</c:v>
                  </c:pt>
                </c:numCache>
              </c:numRef>
            </c:plus>
            <c:minus>
              <c:numRef>
                <c:f>Sheet3!$K$37:$K$38</c:f>
                <c:numCache>
                  <c:formatCode>General</c:formatCode>
                  <c:ptCount val="2"/>
                  <c:pt idx="0">
                    <c:v>5.8803888517886267E-2</c:v>
                  </c:pt>
                  <c:pt idx="1">
                    <c:v>2.4527124971578704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3!$K$44:$K$45</c:f>
              <c:strCache>
                <c:ptCount val="2"/>
                <c:pt idx="0">
                  <c:v>Nip </c:v>
                </c:pt>
                <c:pt idx="1">
                  <c:v>CSSL-9</c:v>
                </c:pt>
              </c:strCache>
            </c:strRef>
          </c:cat>
          <c:val>
            <c:numRef>
              <c:f>Sheet3!$L$44:$L$45</c:f>
              <c:numCache>
                <c:formatCode>General</c:formatCode>
                <c:ptCount val="2"/>
                <c:pt idx="0">
                  <c:v>1.0345066141885262</c:v>
                </c:pt>
                <c:pt idx="1">
                  <c:v>1.0475836609625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C7F-4EB3-AC6B-C9C0F40FC7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315409280"/>
        <c:axId val="315411576"/>
      </c:barChart>
      <c:catAx>
        <c:axId val="315409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315411576"/>
        <c:crosses val="autoZero"/>
        <c:auto val="1"/>
        <c:lblAlgn val="ctr"/>
        <c:lblOffset val="100"/>
        <c:noMultiLvlLbl val="0"/>
      </c:catAx>
      <c:valAx>
        <c:axId val="315411576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3154092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543817033997319"/>
          <c:y val="3.4244065951133558E-2"/>
          <c:w val="0.70561294820653708"/>
          <c:h val="0.9161805619819325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60000"/>
                <a:lumOff val="4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L$49:$L$50</c:f>
                <c:numCache>
                  <c:formatCode>General</c:formatCode>
                  <c:ptCount val="2"/>
                  <c:pt idx="0">
                    <c:v>0.285565964611321</c:v>
                  </c:pt>
                  <c:pt idx="1">
                    <c:v>0.29233448531099498</c:v>
                  </c:pt>
                </c:numCache>
              </c:numRef>
            </c:plus>
            <c:minus>
              <c:numRef>
                <c:f>Sheet2!$L$49:$L$50</c:f>
                <c:numCache>
                  <c:formatCode>General</c:formatCode>
                  <c:ptCount val="2"/>
                  <c:pt idx="0">
                    <c:v>0.285565964611321</c:v>
                  </c:pt>
                  <c:pt idx="1">
                    <c:v>0.29233448531099498</c:v>
                  </c:pt>
                </c:numCache>
              </c:numRef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2!$J$49:$J$50</c:f>
              <c:numCache>
                <c:formatCode>General</c:formatCode>
                <c:ptCount val="2"/>
              </c:numCache>
            </c:numRef>
          </c:cat>
          <c:val>
            <c:numRef>
              <c:f>Sheet2!$K$49:$K$50</c:f>
              <c:numCache>
                <c:formatCode>General</c:formatCode>
                <c:ptCount val="2"/>
                <c:pt idx="0">
                  <c:v>1.0655823915825924</c:v>
                </c:pt>
                <c:pt idx="1">
                  <c:v>0.982406447935206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FC-413E-B7A0-B170CC41A1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573798688"/>
        <c:axId val="573791144"/>
      </c:barChart>
      <c:catAx>
        <c:axId val="57379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73791144"/>
        <c:crosses val="autoZero"/>
        <c:auto val="1"/>
        <c:lblAlgn val="ctr"/>
        <c:lblOffset val="100"/>
        <c:noMultiLvlLbl val="0"/>
      </c:catAx>
      <c:valAx>
        <c:axId val="5737911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73798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6FED27-533D-4C2F-96A3-38C026D66261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FFB7C-A235-4241-9546-2785CD185C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3313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1FFB7C-A235-4241-9546-2785CD185CE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64131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256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921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3671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554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889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679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624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915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08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01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633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7196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DFB8186D-7BCD-4323-A4FC-C55AD724EC04}"/>
              </a:ext>
            </a:extLst>
          </p:cNvPr>
          <p:cNvGrpSpPr/>
          <p:nvPr/>
        </p:nvGrpSpPr>
        <p:grpSpPr>
          <a:xfrm>
            <a:off x="549098" y="1563076"/>
            <a:ext cx="5851255" cy="4079933"/>
            <a:chOff x="549098" y="1563076"/>
            <a:chExt cx="5851255" cy="4079933"/>
          </a:xfrm>
        </p:grpSpPr>
        <p:graphicFrame>
          <p:nvGraphicFramePr>
            <p:cNvPr id="51" name="图表 50">
              <a:extLst>
                <a:ext uri="{FF2B5EF4-FFF2-40B4-BE49-F238E27FC236}">
                  <a16:creationId xmlns:a16="http://schemas.microsoft.com/office/drawing/2014/main" id="{066773BC-23E2-4CAD-A656-6C07A4C18EE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11767103"/>
                </p:ext>
              </p:extLst>
            </p:nvPr>
          </p:nvGraphicFramePr>
          <p:xfrm>
            <a:off x="3419831" y="3715984"/>
            <a:ext cx="1508671" cy="19270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9AF5DEAF-4027-49BC-9AAD-4616C3EB58EB}"/>
                </a:ext>
              </a:extLst>
            </p:cNvPr>
            <p:cNvSpPr txBox="1"/>
            <p:nvPr/>
          </p:nvSpPr>
          <p:spPr>
            <a:xfrm>
              <a:off x="3919650" y="3609453"/>
              <a:ext cx="5495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BK12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41" name="图表 40">
              <a:extLst>
                <a:ext uri="{FF2B5EF4-FFF2-40B4-BE49-F238E27FC236}">
                  <a16:creationId xmlns:a16="http://schemas.microsoft.com/office/drawing/2014/main" id="{9759CEAF-AA3E-4061-B63D-F0CDDB70FDB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94993228"/>
                </p:ext>
              </p:extLst>
            </p:nvPr>
          </p:nvGraphicFramePr>
          <p:xfrm>
            <a:off x="1312868" y="1577218"/>
            <a:ext cx="1254548" cy="19330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84680F52-6672-4214-B7F8-AFF0FBF374CD}"/>
                </a:ext>
              </a:extLst>
            </p:cNvPr>
            <p:cNvSpPr txBox="1"/>
            <p:nvPr/>
          </p:nvSpPr>
          <p:spPr>
            <a:xfrm rot="10800000">
              <a:off x="1093402" y="1969501"/>
              <a:ext cx="323165" cy="105708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</a:t>
              </a:r>
              <a:endParaRPr lang="zh-CN" altLang="en-US" sz="900" i="1" dirty="0"/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FCC67AED-360B-48A1-9F87-8BF2E42F039F}"/>
                </a:ext>
              </a:extLst>
            </p:cNvPr>
            <p:cNvSpPr txBox="1"/>
            <p:nvPr/>
          </p:nvSpPr>
          <p:spPr>
            <a:xfrm rot="10800000">
              <a:off x="549098" y="4126945"/>
              <a:ext cx="323165" cy="105708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</a:t>
              </a:r>
              <a:endParaRPr lang="zh-CN" altLang="en-US" sz="900" i="1" dirty="0"/>
            </a:p>
          </p:txBody>
        </p:sp>
        <p:graphicFrame>
          <p:nvGraphicFramePr>
            <p:cNvPr id="31" name="图表 30">
              <a:extLst>
                <a:ext uri="{FF2B5EF4-FFF2-40B4-BE49-F238E27FC236}">
                  <a16:creationId xmlns:a16="http://schemas.microsoft.com/office/drawing/2014/main" id="{24BE51D8-61C0-4B13-845F-100BF19CBE7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8264249"/>
                </p:ext>
              </p:extLst>
            </p:nvPr>
          </p:nvGraphicFramePr>
          <p:xfrm>
            <a:off x="1352381" y="1713856"/>
            <a:ext cx="1254548" cy="179578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7E52ADD1-8633-4986-BDD7-03BC46CC0F4F}"/>
                </a:ext>
              </a:extLst>
            </p:cNvPr>
            <p:cNvSpPr txBox="1"/>
            <p:nvPr/>
          </p:nvSpPr>
          <p:spPr>
            <a:xfrm>
              <a:off x="1894840" y="1585140"/>
              <a:ext cx="5172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PO2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43" name="图表 42">
              <a:extLst>
                <a:ext uri="{FF2B5EF4-FFF2-40B4-BE49-F238E27FC236}">
                  <a16:creationId xmlns:a16="http://schemas.microsoft.com/office/drawing/2014/main" id="{B55C8011-430E-4AFB-9C8B-E0B65AAB7A3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20905588"/>
                </p:ext>
              </p:extLst>
            </p:nvPr>
          </p:nvGraphicFramePr>
          <p:xfrm>
            <a:off x="2640621" y="1713856"/>
            <a:ext cx="1249712" cy="179954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AEE3DD35-8C28-475F-90B6-2AC51059024C}"/>
                </a:ext>
              </a:extLst>
            </p:cNvPr>
            <p:cNvSpPr txBox="1"/>
            <p:nvPr/>
          </p:nvSpPr>
          <p:spPr>
            <a:xfrm>
              <a:off x="3204566" y="1569323"/>
              <a:ext cx="520291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TH7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A3DFAC16-B103-4F34-8273-07A833ADA103}"/>
                </a:ext>
              </a:extLst>
            </p:cNvPr>
            <p:cNvSpPr txBox="1"/>
            <p:nvPr/>
          </p:nvSpPr>
          <p:spPr>
            <a:xfrm>
              <a:off x="1372496" y="3601201"/>
              <a:ext cx="519489" cy="2390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i="1" dirty="0"/>
                <a:t>TAW1</a:t>
              </a:r>
              <a:endParaRPr lang="zh-CN" altLang="en-US" i="1" dirty="0"/>
            </a:p>
          </p:txBody>
        </p:sp>
        <p:graphicFrame>
          <p:nvGraphicFramePr>
            <p:cNvPr id="45" name="图表 44">
              <a:extLst>
                <a:ext uri="{FF2B5EF4-FFF2-40B4-BE49-F238E27FC236}">
                  <a16:creationId xmlns:a16="http://schemas.microsoft.com/office/drawing/2014/main" id="{7CF3D934-043B-4FA8-9912-87A50BF7AE1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85994892"/>
                </p:ext>
              </p:extLst>
            </p:nvPr>
          </p:nvGraphicFramePr>
          <p:xfrm>
            <a:off x="3919650" y="1706034"/>
            <a:ext cx="1350850" cy="180149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548737BC-33CE-401A-B6FB-DA7733850236}"/>
                </a:ext>
              </a:extLst>
            </p:cNvPr>
            <p:cNvSpPr txBox="1"/>
            <p:nvPr/>
          </p:nvSpPr>
          <p:spPr>
            <a:xfrm>
              <a:off x="4503711" y="1563076"/>
              <a:ext cx="4868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P1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52" name="图表 51">
              <a:extLst>
                <a:ext uri="{FF2B5EF4-FFF2-40B4-BE49-F238E27FC236}">
                  <a16:creationId xmlns:a16="http://schemas.microsoft.com/office/drawing/2014/main" id="{F1D80FE2-659A-45D9-9D14-4F016C05A6A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19750760"/>
                </p:ext>
              </p:extLst>
            </p:nvPr>
          </p:nvGraphicFramePr>
          <p:xfrm>
            <a:off x="2113267" y="3741379"/>
            <a:ext cx="1313935" cy="18823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09417A99-465F-44FF-9B9F-00748B4435EA}"/>
                </a:ext>
              </a:extLst>
            </p:cNvPr>
            <p:cNvSpPr txBox="1"/>
            <p:nvPr/>
          </p:nvSpPr>
          <p:spPr>
            <a:xfrm>
              <a:off x="2647865" y="3618026"/>
              <a:ext cx="5788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i="1" dirty="0"/>
                <a:t>FUWA</a:t>
              </a:r>
              <a:endParaRPr lang="zh-CN" altLang="en-US" i="1" dirty="0"/>
            </a:p>
          </p:txBody>
        </p:sp>
        <p:graphicFrame>
          <p:nvGraphicFramePr>
            <p:cNvPr id="53" name="图表 52">
              <a:extLst>
                <a:ext uri="{FF2B5EF4-FFF2-40B4-BE49-F238E27FC236}">
                  <a16:creationId xmlns:a16="http://schemas.microsoft.com/office/drawing/2014/main" id="{8E395256-6A8A-4296-A0AD-9A62BF4B1B7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86060004"/>
                </p:ext>
              </p:extLst>
            </p:nvPr>
          </p:nvGraphicFramePr>
          <p:xfrm>
            <a:off x="828263" y="3691973"/>
            <a:ext cx="1312987" cy="19270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pSp>
          <p:nvGrpSpPr>
            <p:cNvPr id="19" name="组合 18">
              <a:extLst>
                <a:ext uri="{FF2B5EF4-FFF2-40B4-BE49-F238E27FC236}">
                  <a16:creationId xmlns:a16="http://schemas.microsoft.com/office/drawing/2014/main" id="{041D3AFA-35D0-479B-9764-5AAEBBF8F852}"/>
                </a:ext>
              </a:extLst>
            </p:cNvPr>
            <p:cNvGrpSpPr/>
            <p:nvPr/>
          </p:nvGrpSpPr>
          <p:grpSpPr>
            <a:xfrm>
              <a:off x="4829788" y="3601201"/>
              <a:ext cx="1570565" cy="2034145"/>
              <a:chOff x="4007807" y="506450"/>
              <a:chExt cx="2931542" cy="3032510"/>
            </a:xfrm>
          </p:grpSpPr>
          <p:graphicFrame>
            <p:nvGraphicFramePr>
              <p:cNvPr id="21" name="图表 20">
                <a:extLst>
                  <a:ext uri="{FF2B5EF4-FFF2-40B4-BE49-F238E27FC236}">
                    <a16:creationId xmlns:a16="http://schemas.microsoft.com/office/drawing/2014/main" id="{774A2039-0E9B-4347-AD67-11CE1DE4A71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33657463"/>
                  </p:ext>
                </p:extLst>
              </p:nvPr>
            </p:nvGraphicFramePr>
            <p:xfrm>
              <a:off x="4007807" y="627835"/>
              <a:ext cx="2931542" cy="270942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D864229F-803E-41D0-861E-5AF10982A32D}"/>
                  </a:ext>
                </a:extLst>
              </p:cNvPr>
              <p:cNvSpPr txBox="1"/>
              <p:nvPr/>
            </p:nvSpPr>
            <p:spPr>
              <a:xfrm>
                <a:off x="4776465" y="3194835"/>
                <a:ext cx="814918" cy="3228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ip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45CE40FF-AF15-44F9-9BEB-E5EC0C11EB44}"/>
                  </a:ext>
                </a:extLst>
              </p:cNvPr>
              <p:cNvSpPr txBox="1"/>
              <p:nvPr/>
            </p:nvSpPr>
            <p:spPr>
              <a:xfrm>
                <a:off x="5697787" y="3194835"/>
                <a:ext cx="1157098" cy="3441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SSL-9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C098A4EF-965C-4D3E-AF61-DC3E81172901}"/>
                  </a:ext>
                </a:extLst>
              </p:cNvPr>
              <p:cNvSpPr txBox="1"/>
              <p:nvPr/>
            </p:nvSpPr>
            <p:spPr>
              <a:xfrm>
                <a:off x="5231735" y="506450"/>
                <a:ext cx="1015470" cy="3228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b="1" i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sz="9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NP1</a:t>
                </a:r>
                <a:endParaRPr lang="zh-CN" altLang="en-US" sz="9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266819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68</TotalTime>
  <Words>14</Words>
  <Application>Microsoft Office PowerPoint</Application>
  <PresentationFormat>A4 纸张(210x297 毫米)</PresentationFormat>
  <Paragraphs>1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丽春 曹</dc:creator>
  <cp:lastModifiedBy>fengzhishu2009@163.com</cp:lastModifiedBy>
  <cp:revision>644</cp:revision>
  <dcterms:created xsi:type="dcterms:W3CDTF">2019-11-29T08:26:13Z</dcterms:created>
  <dcterms:modified xsi:type="dcterms:W3CDTF">2021-07-01T12:32:25Z</dcterms:modified>
</cp:coreProperties>
</file>